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42109-1B01-4B43-A037-02EEF426E9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3175A1-892B-4398-B2AB-5970FB5C46F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701F1-D7EA-4D67-9AD9-E10102CA64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74BB79-142D-4903-A714-351D199AA92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472242-FA80-4B2F-BC8C-525641F125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5AA35-C890-444E-8421-987B28D3D3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EFD3F-C93F-4371-847F-591FD5619E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FAECA-C6B8-48BA-AFAB-96376F1F06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37CDCA-9B7F-4244-811F-9297F2A32A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50D585-2ED9-4D7F-BFC9-C8EC162B2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151CB5-2F89-451B-A63A-6A59E46A01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E3869-5526-474A-A61C-FA29422491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7255A2-35E0-456D-8784-CAAB43163237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85680" y="1157400"/>
            <a:ext cx="8972640" cy="454320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2" name=""/>
          <p:cNvGraphicFramePr/>
          <p:nvPr/>
        </p:nvGraphicFramePr>
        <p:xfrm>
          <a:off x="1835280" y="6453360"/>
          <a:ext cx="6070320" cy="190440"/>
        </p:xfrm>
        <a:graphic>
          <a:graphicData uri="http://schemas.openxmlformats.org/drawingml/2006/table">
            <a:tbl>
              <a:tblPr/>
              <a:tblGrid>
                <a:gridCol w="6070320"/>
              </a:tblGrid>
              <a:tr h="1904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dditional file 8:        GO annotation of differentially regulated genes in banana transcriptom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9-12T10:54:01Z</dcterms:created>
  <dc:creator>pktlab</dc:creator>
  <dc:description/>
  <dc:language>en-US</dc:language>
  <cp:lastModifiedBy>pktlab</cp:lastModifiedBy>
  <dcterms:modified xsi:type="dcterms:W3CDTF">2014-09-12T10:55:36Z</dcterms:modified>
  <cp:revision>1</cp:revision>
  <dc:subject/>
  <dc:title>Slide 1</dc:title>
</cp:coreProperties>
</file>